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21"/>
  </p:notesMasterIdLst>
  <p:sldIdLst>
    <p:sldId id="1092" r:id="rId2"/>
    <p:sldId id="1073" r:id="rId3"/>
    <p:sldId id="1080" r:id="rId4"/>
    <p:sldId id="1084" r:id="rId5"/>
    <p:sldId id="1077" r:id="rId6"/>
    <p:sldId id="1075" r:id="rId7"/>
    <p:sldId id="1085" r:id="rId8"/>
    <p:sldId id="1081" r:id="rId9"/>
    <p:sldId id="1086" r:id="rId10"/>
    <p:sldId id="1087" r:id="rId11"/>
    <p:sldId id="1082" r:id="rId12"/>
    <p:sldId id="1083" r:id="rId13"/>
    <p:sldId id="1050" r:id="rId14"/>
    <p:sldId id="1088" r:id="rId15"/>
    <p:sldId id="1089" r:id="rId16"/>
    <p:sldId id="1090" r:id="rId17"/>
    <p:sldId id="1091" r:id="rId18"/>
    <p:sldId id="1058" r:id="rId19"/>
    <p:sldId id="1078" r:id="rId20"/>
  </p:sldIdLst>
  <p:sldSz cx="18288000" cy="10287000"/>
  <p:notesSz cx="6858000" cy="9144000"/>
  <p:embeddedFontLst>
    <p:embeddedFont>
      <p:font typeface="Assistant" pitchFamily="2" charset="-79"/>
      <p:regular r:id="rId22"/>
      <p:bold r:id="rId23"/>
    </p:embeddedFont>
    <p:embeddedFont>
      <p:font typeface="Assistant Bold" charset="-79"/>
      <p:regular r:id="rId24"/>
      <p:bold r:id="rId25"/>
    </p:embeddedFont>
    <p:embeddedFont>
      <p:font typeface="Assistant ExtraBold" pitchFamily="2" charset="-79"/>
      <p:bold r:id="rId26"/>
    </p:embeddedFont>
    <p:embeddedFont>
      <p:font typeface="Assistant Regular" charset="-79"/>
      <p:regular r:id="rId27"/>
    </p:embeddedFont>
    <p:embeddedFont>
      <p:font typeface="Assistant SemiBold" pitchFamily="2" charset="-79"/>
      <p:bold r:id="rId28"/>
    </p:embeddedFont>
    <p:embeddedFont>
      <p:font typeface="Calibri" panose="020F0502020204030204" pitchFamily="34" charset="0"/>
      <p:regular r:id="rId29"/>
      <p:bold r:id="rId30"/>
      <p:italic r:id="rId31"/>
      <p:boldItalic r:id="rId32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9B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63" autoAdjust="0"/>
    <p:restoredTop sz="77295" autoAdjust="0"/>
  </p:normalViewPr>
  <p:slideViewPr>
    <p:cSldViewPr>
      <p:cViewPr varScale="1">
        <p:scale>
          <a:sx n="43" d="100"/>
          <a:sy n="43" d="100"/>
        </p:scale>
        <p:origin x="1409" y="3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font" Target="fonts/font5.fntdata"/><Relationship Id="rId3" Type="http://schemas.openxmlformats.org/officeDocument/2006/relationships/slide" Target="slides/slide2.xml"/><Relationship Id="rId21" Type="http://schemas.openxmlformats.org/officeDocument/2006/relationships/notesMaster" Target="notesMasters/notesMaster1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font" Target="fonts/font4.fntdata"/><Relationship Id="rId33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font" Target="fonts/font8.fnt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font" Target="fonts/font3.fntdata"/><Relationship Id="rId32" Type="http://schemas.openxmlformats.org/officeDocument/2006/relationships/font" Target="fonts/font11.fntdata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font" Target="fonts/font2.fntdata"/><Relationship Id="rId28" Type="http://schemas.openxmlformats.org/officeDocument/2006/relationships/font" Target="fonts/font7.fntdata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font" Target="fonts/font10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font" Target="fonts/font1.fntdata"/><Relationship Id="rId27" Type="http://schemas.openxmlformats.org/officeDocument/2006/relationships/font" Target="fonts/font6.fntdata"/><Relationship Id="rId30" Type="http://schemas.openxmlformats.org/officeDocument/2006/relationships/font" Target="fonts/font9.fntdata"/><Relationship Id="rId35" Type="http://schemas.openxmlformats.org/officeDocument/2006/relationships/theme" Target="theme/theme1.xml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2763"/>
            <a:ext cx="3429000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‹#›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7988891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52000523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1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715471764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195116503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626675697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635208524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5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401853071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6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188392986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7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986955448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8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178437090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9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1993368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25427199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33533264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5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78183818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6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22125431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7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61842419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8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91039768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9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33725327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dirty="0"/>
              <a:t>Handout for Mediterranean could go here as a guideline</a:t>
            </a:r>
          </a:p>
          <a:p>
            <a:pPr lvl="0"/>
            <a:r>
              <a:rPr lang="en-US" dirty="0"/>
              <a:t>MIND Diet Harvard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0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0765038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jpe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svg"/><Relationship Id="rId13" Type="http://schemas.openxmlformats.org/officeDocument/2006/relationships/image" Target="../media/image26.png"/><Relationship Id="rId18" Type="http://schemas.openxmlformats.org/officeDocument/2006/relationships/image" Target="../media/image31.svg"/><Relationship Id="rId3" Type="http://schemas.openxmlformats.org/officeDocument/2006/relationships/image" Target="../media/image16.png"/><Relationship Id="rId21" Type="http://schemas.openxmlformats.org/officeDocument/2006/relationships/image" Target="../media/image34.png"/><Relationship Id="rId7" Type="http://schemas.openxmlformats.org/officeDocument/2006/relationships/image" Target="../media/image20.png"/><Relationship Id="rId12" Type="http://schemas.openxmlformats.org/officeDocument/2006/relationships/image" Target="../media/image25.svg"/><Relationship Id="rId17" Type="http://schemas.openxmlformats.org/officeDocument/2006/relationships/image" Target="../media/image30.png"/><Relationship Id="rId2" Type="http://schemas.openxmlformats.org/officeDocument/2006/relationships/notesSlide" Target="../notesSlides/notesSlide10.xml"/><Relationship Id="rId16" Type="http://schemas.openxmlformats.org/officeDocument/2006/relationships/image" Target="../media/image29.svg"/><Relationship Id="rId20" Type="http://schemas.openxmlformats.org/officeDocument/2006/relationships/image" Target="../media/image33.sv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svg"/><Relationship Id="rId11" Type="http://schemas.openxmlformats.org/officeDocument/2006/relationships/image" Target="../media/image24.png"/><Relationship Id="rId5" Type="http://schemas.openxmlformats.org/officeDocument/2006/relationships/image" Target="../media/image18.png"/><Relationship Id="rId15" Type="http://schemas.openxmlformats.org/officeDocument/2006/relationships/image" Target="../media/image28.png"/><Relationship Id="rId10" Type="http://schemas.openxmlformats.org/officeDocument/2006/relationships/image" Target="../media/image23.svg"/><Relationship Id="rId19" Type="http://schemas.openxmlformats.org/officeDocument/2006/relationships/image" Target="../media/image32.png"/><Relationship Id="rId4" Type="http://schemas.openxmlformats.org/officeDocument/2006/relationships/image" Target="../media/image17.svg"/><Relationship Id="rId9" Type="http://schemas.openxmlformats.org/officeDocument/2006/relationships/image" Target="../media/image22.png"/><Relationship Id="rId14" Type="http://schemas.openxmlformats.org/officeDocument/2006/relationships/image" Target="../media/image27.svg"/><Relationship Id="rId22" Type="http://schemas.openxmlformats.org/officeDocument/2006/relationships/image" Target="../media/image35.sv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jpe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jpe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jpe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jpe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jpe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jpe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jpeg"/><Relationship Id="rId4" Type="http://schemas.openxmlformats.org/officeDocument/2006/relationships/image" Target="../media/image5.sv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jpeg"/><Relationship Id="rId4" Type="http://schemas.openxmlformats.org/officeDocument/2006/relationships/image" Target="../media/image5.sv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sv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 rot="5400000">
            <a:off x="9800951" y="1799951"/>
            <a:ext cx="10287000" cy="6687099"/>
            <a:chOff x="0" y="0"/>
            <a:chExt cx="3479800" cy="2262056"/>
          </a:xfrm>
        </p:grpSpPr>
        <p:sp>
          <p:nvSpPr>
            <p:cNvPr id="3" name="Freeform 3"/>
            <p:cNvSpPr/>
            <p:nvPr/>
          </p:nvSpPr>
          <p:spPr>
            <a:xfrm>
              <a:off x="0" y="0"/>
              <a:ext cx="3479800" cy="2262056"/>
            </a:xfrm>
            <a:custGeom>
              <a:avLst/>
              <a:gdLst/>
              <a:ahLst/>
              <a:cxnLst/>
              <a:rect l="l" t="t" r="r" b="b"/>
              <a:pathLst>
                <a:path w="3479800" h="2262056">
                  <a:moveTo>
                    <a:pt x="0" y="0"/>
                  </a:moveTo>
                  <a:lnTo>
                    <a:pt x="3479800" y="0"/>
                  </a:lnTo>
                  <a:lnTo>
                    <a:pt x="3479800" y="2262056"/>
                  </a:lnTo>
                  <a:lnTo>
                    <a:pt x="0" y="2262056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4" name="Group 4"/>
          <p:cNvGrpSpPr/>
          <p:nvPr/>
        </p:nvGrpSpPr>
        <p:grpSpPr>
          <a:xfrm rot="5400000">
            <a:off x="6057901" y="-3962397"/>
            <a:ext cx="6172199" cy="18288000"/>
            <a:chOff x="0" y="0"/>
            <a:chExt cx="2809995" cy="7819962"/>
          </a:xfrm>
        </p:grpSpPr>
        <p:sp>
          <p:nvSpPr>
            <p:cNvPr id="5" name="Freeform 5"/>
            <p:cNvSpPr/>
            <p:nvPr/>
          </p:nvSpPr>
          <p:spPr>
            <a:xfrm>
              <a:off x="0" y="0"/>
              <a:ext cx="2809995" cy="7819962"/>
            </a:xfrm>
            <a:custGeom>
              <a:avLst/>
              <a:gdLst/>
              <a:ahLst/>
              <a:cxnLst/>
              <a:rect l="l" t="t" r="r" b="b"/>
              <a:pathLst>
                <a:path w="2809995" h="7819962">
                  <a:moveTo>
                    <a:pt x="0" y="0"/>
                  </a:moveTo>
                  <a:lnTo>
                    <a:pt x="2809995" y="0"/>
                  </a:lnTo>
                  <a:lnTo>
                    <a:pt x="2809995" y="7819962"/>
                  </a:lnTo>
                  <a:lnTo>
                    <a:pt x="0" y="7819962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6" name="Group 6"/>
          <p:cNvGrpSpPr/>
          <p:nvPr/>
        </p:nvGrpSpPr>
        <p:grpSpPr>
          <a:xfrm rot="5400000">
            <a:off x="-2037565" y="4918237"/>
            <a:ext cx="6583056" cy="450526"/>
            <a:chOff x="0" y="0"/>
            <a:chExt cx="2226861" cy="152400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2226861" cy="152400"/>
            </a:xfrm>
            <a:custGeom>
              <a:avLst/>
              <a:gdLst/>
              <a:ahLst/>
              <a:cxnLst/>
              <a:rect l="l" t="t" r="r" b="b"/>
              <a:pathLst>
                <a:path w="2226861" h="152400">
                  <a:moveTo>
                    <a:pt x="0" y="0"/>
                  </a:moveTo>
                  <a:lnTo>
                    <a:pt x="2226861" y="0"/>
                  </a:lnTo>
                  <a:lnTo>
                    <a:pt x="2226861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8" name="TextBox 8"/>
          <p:cNvSpPr txBox="1"/>
          <p:nvPr/>
        </p:nvSpPr>
        <p:spPr>
          <a:xfrm>
            <a:off x="1869752" y="2882831"/>
            <a:ext cx="16440328" cy="962636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8000" dirty="0">
                <a:solidFill>
                  <a:srgbClr val="777F8F"/>
                </a:solidFill>
                <a:latin typeface="Assistant Bold"/>
              </a:rPr>
              <a:t>e-Healthy Older Adults Modification</a:t>
            </a:r>
          </a:p>
        </p:txBody>
      </p:sp>
      <p:grpSp>
        <p:nvGrpSpPr>
          <p:cNvPr id="11" name="Group 11"/>
          <p:cNvGrpSpPr/>
          <p:nvPr/>
        </p:nvGrpSpPr>
        <p:grpSpPr>
          <a:xfrm>
            <a:off x="13317560" y="4372151"/>
            <a:ext cx="4888841" cy="1134219"/>
            <a:chOff x="1573698" y="-152998"/>
            <a:chExt cx="7219847" cy="1512292"/>
          </a:xfrm>
        </p:grpSpPr>
        <p:grpSp>
          <p:nvGrpSpPr>
            <p:cNvPr id="12" name="Group 12"/>
            <p:cNvGrpSpPr/>
            <p:nvPr/>
          </p:nvGrpSpPr>
          <p:grpSpPr>
            <a:xfrm rot="5400000">
              <a:off x="4370825" y="-2950125"/>
              <a:ext cx="1512292" cy="7106545"/>
              <a:chOff x="-38816" y="59846"/>
              <a:chExt cx="383674" cy="1802957"/>
            </a:xfrm>
          </p:grpSpPr>
          <p:sp>
            <p:nvSpPr>
              <p:cNvPr id="13" name="Freeform 13"/>
              <p:cNvSpPr/>
              <p:nvPr/>
            </p:nvSpPr>
            <p:spPr>
              <a:xfrm>
                <a:off x="-38816" y="59846"/>
                <a:ext cx="383674" cy="1802957"/>
              </a:xfrm>
              <a:custGeom>
                <a:avLst/>
                <a:gdLst/>
                <a:ahLst/>
                <a:cxnLst/>
                <a:rect l="l" t="t" r="r" b="b"/>
                <a:pathLst>
                  <a:path w="383674" h="2262056">
                    <a:moveTo>
                      <a:pt x="0" y="0"/>
                    </a:moveTo>
                    <a:lnTo>
                      <a:pt x="383674" y="0"/>
                    </a:lnTo>
                    <a:lnTo>
                      <a:pt x="383674" y="2262056"/>
                    </a:lnTo>
                    <a:lnTo>
                      <a:pt x="0" y="2262056"/>
                    </a:lnTo>
                    <a:close/>
                  </a:path>
                </a:pathLst>
              </a:custGeom>
              <a:solidFill>
                <a:srgbClr val="FFFFFF"/>
              </a:solidFill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4" name="TextBox 14"/>
            <p:cNvSpPr txBox="1"/>
            <p:nvPr/>
          </p:nvSpPr>
          <p:spPr>
            <a:xfrm>
              <a:off x="1687000" y="-12403"/>
              <a:ext cx="7106545" cy="1231107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ExtraBold" panose="020B0604020202020204" pitchFamily="2" charset="-79"/>
                  <a:cs typeface="Assistant ExtraBold" panose="020B0604020202020204" pitchFamily="2" charset="-79"/>
                </a:rPr>
                <a:t>WEEK #3</a:t>
              </a:r>
              <a:endParaRPr lang="en-US" sz="3000" spc="874" dirty="0">
                <a:solidFill>
                  <a:schemeClr val="tx1">
                    <a:lumMod val="65000"/>
                    <a:lumOff val="35000"/>
                  </a:schemeClr>
                </a:solidFill>
                <a:latin typeface="Assistant SemiBold" panose="020B0604020202020204" pitchFamily="2" charset="-79"/>
                <a:cs typeface="Assistant SemiBold" panose="020B0604020202020204" pitchFamily="2" charset="-79"/>
              </a:endParaRPr>
            </a:p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SemiBold" panose="020B0604020202020204" pitchFamily="2" charset="-79"/>
                  <a:cs typeface="Assistant SemiBold" panose="020B0604020202020204" pitchFamily="2" charset="-79"/>
                </a:rPr>
                <a:t>Healthy Eating!</a:t>
              </a:r>
            </a:p>
          </p:txBody>
        </p:sp>
      </p:grpSp>
      <p:sp>
        <p:nvSpPr>
          <p:cNvPr id="15" name="TextBox 8">
            <a:extLst>
              <a:ext uri="{FF2B5EF4-FFF2-40B4-BE49-F238E27FC236}">
                <a16:creationId xmlns:a16="http://schemas.microsoft.com/office/drawing/2014/main" id="{CB1C0516-F4A3-7149-B520-4B1A279333E4}"/>
              </a:ext>
            </a:extLst>
          </p:cNvPr>
          <p:cNvSpPr txBox="1"/>
          <p:nvPr/>
        </p:nvSpPr>
        <p:spPr>
          <a:xfrm>
            <a:off x="1868032" y="4417476"/>
            <a:ext cx="10490976" cy="3046988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r>
              <a:rPr lang="en-US" sz="6600" dirty="0">
                <a:solidFill>
                  <a:schemeClr val="tx1">
                    <a:lumMod val="50000"/>
                    <a:lumOff val="50000"/>
                  </a:schemeClr>
                </a:solidFill>
                <a:latin typeface="Assistant Regular"/>
              </a:rPr>
              <a:t>Diabetes Prevention Program</a:t>
            </a: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E045AE-042B-314E-916D-A119929EE2E6}"/>
              </a:ext>
            </a:extLst>
          </p:cNvPr>
          <p:cNvSpPr txBox="1"/>
          <p:nvPr/>
        </p:nvSpPr>
        <p:spPr>
          <a:xfrm>
            <a:off x="4191000" y="-4610367"/>
            <a:ext cx="1160934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6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ssistant" pitchFamily="2" charset="-79"/>
                <a:cs typeface="Assistant" pitchFamily="2" charset="-79"/>
              </a:rPr>
              <a:t>OPEN REPORTS</a:t>
            </a:r>
          </a:p>
          <a:p>
            <a:pPr marL="457200" indent="-457200"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3600" b="1" dirty="0">
              <a:solidFill>
                <a:schemeClr val="tx1">
                  <a:lumMod val="75000"/>
                  <a:lumOff val="25000"/>
                </a:schemeClr>
              </a:solidFill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17" name="Group 4">
            <a:extLst>
              <a:ext uri="{FF2B5EF4-FFF2-40B4-BE49-F238E27FC236}">
                <a16:creationId xmlns:a16="http://schemas.microsoft.com/office/drawing/2014/main" id="{EC4C4EB6-F1A7-44EA-8720-D61D793A63B9}"/>
              </a:ext>
            </a:extLst>
          </p:cNvPr>
          <p:cNvGrpSpPr/>
          <p:nvPr/>
        </p:nvGrpSpPr>
        <p:grpSpPr>
          <a:xfrm rot="5400000">
            <a:off x="-2410774" y="4496751"/>
            <a:ext cx="6172201" cy="1369706"/>
            <a:chOff x="101672" y="0"/>
            <a:chExt cx="2639238" cy="585687"/>
          </a:xfrm>
        </p:grpSpPr>
        <p:sp>
          <p:nvSpPr>
            <p:cNvPr id="18" name="Freeform 5">
              <a:extLst>
                <a:ext uri="{FF2B5EF4-FFF2-40B4-BE49-F238E27FC236}">
                  <a16:creationId xmlns:a16="http://schemas.microsoft.com/office/drawing/2014/main" id="{E9F97B7F-5369-4904-8160-A5F48929EAA3}"/>
                </a:ext>
              </a:extLst>
            </p:cNvPr>
            <p:cNvSpPr/>
            <p:nvPr/>
          </p:nvSpPr>
          <p:spPr>
            <a:xfrm>
              <a:off x="101672" y="0"/>
              <a:ext cx="2639238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9" name="TextBox 12">
            <a:extLst>
              <a:ext uri="{FF2B5EF4-FFF2-40B4-BE49-F238E27FC236}">
                <a16:creationId xmlns:a16="http://schemas.microsoft.com/office/drawing/2014/main" id="{88C3F6D3-2605-4694-A7A9-EDE50F587A24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Dairy Foods- 2 servings a day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07E4156-BB74-4F6B-99B5-488D86221CA7}"/>
              </a:ext>
            </a:extLst>
          </p:cNvPr>
          <p:cNvSpPr txBox="1"/>
          <p:nvPr/>
        </p:nvSpPr>
        <p:spPr>
          <a:xfrm>
            <a:off x="1447800" y="1866276"/>
            <a:ext cx="16156926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Move to low-fat and fat-free dairy, or fortified soy milk &amp; milk-alternativ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200" dirty="0"/>
              <a:t>1 cup of low-fat milk or yogurt is a serving (</a:t>
            </a:r>
            <a:r>
              <a:rPr lang="en-US" sz="3200" u="sng" dirty="0"/>
              <a:t>remember non-dairy versions are lower in calories</a:t>
            </a:r>
            <a:r>
              <a:rPr lang="en-US" sz="3200" dirty="0"/>
              <a:t>!)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1.5 ounces of hard cheeses, like parmesan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1/3 cup of shredded low-fat cheese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/>
              <a:t>Watch for creamy foods like smoothies, ice cream, sweetened yogurts, and sauces that bring extra calories along for the ride.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/>
              <a:t>Butter is almost entirely FAT, </a:t>
            </a:r>
            <a:r>
              <a:rPr lang="en-US" sz="2800" u="sng" dirty="0"/>
              <a:t>a great way to reduce fat is to not add more when cooking</a:t>
            </a:r>
            <a:r>
              <a:rPr lang="en-US" sz="2800" dirty="0"/>
              <a:t>!</a:t>
            </a:r>
            <a:endParaRPr lang="en-US" sz="2400" dirty="0"/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2400" dirty="0"/>
          </a:p>
        </p:txBody>
      </p:sp>
      <p:pic>
        <p:nvPicPr>
          <p:cNvPr id="8194" name="Picture 2">
            <a:extLst>
              <a:ext uri="{FF2B5EF4-FFF2-40B4-BE49-F238E27FC236}">
                <a16:creationId xmlns:a16="http://schemas.microsoft.com/office/drawing/2014/main" id="{7FB31C78-2779-4315-B2A2-BB7805FB3DA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67000" y="6057900"/>
            <a:ext cx="5905500" cy="381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6" name="Picture 4" descr="Greek Yogurt Breakfast Bowls with Toppings – Modern Honey">
            <a:extLst>
              <a:ext uri="{FF2B5EF4-FFF2-40B4-BE49-F238E27FC236}">
                <a16:creationId xmlns:a16="http://schemas.microsoft.com/office/drawing/2014/main" id="{F50388F1-4EA8-4619-BDA5-AEC10A4F1B3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63200" y="6057900"/>
            <a:ext cx="6160149" cy="381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6993295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Strategies for Succes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graphicFrame>
        <p:nvGraphicFramePr>
          <p:cNvPr id="5" name="Table 16">
            <a:extLst>
              <a:ext uri="{FF2B5EF4-FFF2-40B4-BE49-F238E27FC236}">
                <a16:creationId xmlns:a16="http://schemas.microsoft.com/office/drawing/2014/main" id="{D1075E32-9CD1-4306-AE60-631FC1FCA58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68896876"/>
              </p:ext>
            </p:extLst>
          </p:nvPr>
        </p:nvGraphicFramePr>
        <p:xfrm>
          <a:off x="1643334" y="2188022"/>
          <a:ext cx="16035066" cy="7076442"/>
        </p:xfrm>
        <a:graphic>
          <a:graphicData uri="http://schemas.openxmlformats.org/drawingml/2006/table">
            <a:tbl>
              <a:tblPr firstRow="1" bandRow="1">
                <a:tableStyleId>{16D9F66E-5EB9-4882-86FB-DCBF35E3C3E4}</a:tableStyleId>
              </a:tblPr>
              <a:tblGrid>
                <a:gridCol w="7986693">
                  <a:extLst>
                    <a:ext uri="{9D8B030D-6E8A-4147-A177-3AD203B41FA5}">
                      <a16:colId xmlns:a16="http://schemas.microsoft.com/office/drawing/2014/main" val="597127771"/>
                    </a:ext>
                  </a:extLst>
                </a:gridCol>
                <a:gridCol w="8048373">
                  <a:extLst>
                    <a:ext uri="{9D8B030D-6E8A-4147-A177-3AD203B41FA5}">
                      <a16:colId xmlns:a16="http://schemas.microsoft.com/office/drawing/2014/main" val="3035677441"/>
                    </a:ext>
                  </a:extLst>
                </a:gridCol>
              </a:tblGrid>
              <a:tr h="1464734">
                <a:tc>
                  <a:txBody>
                    <a:bodyPr/>
                    <a:lstStyle/>
                    <a:p>
                      <a:r>
                        <a:rPr lang="en-US" sz="3200" dirty="0"/>
                        <a:t>                           DO IT YOUR WAY</a:t>
                      </a:r>
                    </a:p>
                    <a:p>
                      <a:pPr algn="ctr"/>
                      <a:r>
                        <a:rPr lang="en-US" sz="2600" b="0" dirty="0"/>
                        <a:t>Try EVERYTHING to find what you like </a:t>
                      </a:r>
                    </a:p>
                    <a:p>
                      <a:pPr algn="ctr"/>
                      <a:r>
                        <a:rPr lang="en-US" sz="2600" b="0" dirty="0"/>
                        <a:t>So that it works for you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3200" b="1" dirty="0"/>
                        <a:t>VARY YOUR PROTEIN ROUTINE</a:t>
                      </a:r>
                    </a:p>
                    <a:p>
                      <a:pPr algn="ctr"/>
                      <a:r>
                        <a:rPr lang="en-US" sz="2600" b="0" dirty="0"/>
                        <a:t>Try main dishes made with beans or seafood</a:t>
                      </a:r>
                    </a:p>
                    <a:p>
                      <a:pPr algn="ctr"/>
                      <a:r>
                        <a:rPr lang="en-US" sz="2600" b="0" dirty="0"/>
                        <a:t> like tuna salad or bean chili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3477002"/>
                  </a:ext>
                </a:extLst>
              </a:tr>
              <a:tr h="596627">
                <a:tc>
                  <a:txBody>
                    <a:bodyPr/>
                    <a:lstStyle/>
                    <a:p>
                      <a:pPr algn="ctr"/>
                      <a:r>
                        <a:rPr lang="en-US" sz="3200" b="1" dirty="0"/>
                        <a:t>LOAD UP ON FRUIT &amp; VEGGIES</a:t>
                      </a:r>
                    </a:p>
                    <a:p>
                      <a:pPr algn="ctr"/>
                      <a:r>
                        <a:rPr lang="en-US" sz="2600" b="0" dirty="0"/>
                        <a:t>Half your plate = whole fruit and veggies</a:t>
                      </a:r>
                    </a:p>
                    <a:p>
                      <a:pPr algn="ctr"/>
                      <a:r>
                        <a:rPr lang="en-US" sz="2600" b="0" dirty="0"/>
                        <a:t>Variety is the spice of lif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3200" b="1" dirty="0"/>
                        <a:t>REDUCE SODIUM, SAT FAT, &amp; SUGAR</a:t>
                      </a:r>
                    </a:p>
                    <a:p>
                      <a:pPr algn="ctr"/>
                      <a:r>
                        <a:rPr lang="en-US" sz="2400" b="0" dirty="0"/>
                        <a:t>Choose vegetable oils instead of butter, </a:t>
                      </a:r>
                    </a:p>
                    <a:p>
                      <a:pPr algn="ctr"/>
                      <a:r>
                        <a:rPr lang="en-US" sz="2400" b="0" dirty="0"/>
                        <a:t>and sauces made with oils instead of creams and cheese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62064699"/>
                  </a:ext>
                </a:extLst>
              </a:tr>
              <a:tr h="1185944">
                <a:tc>
                  <a:txBody>
                    <a:bodyPr/>
                    <a:lstStyle/>
                    <a:p>
                      <a:pPr algn="ctr"/>
                      <a:r>
                        <a:rPr lang="en-US" sz="3200" b="1" dirty="0"/>
                        <a:t>GET YOUR WHOLE GRAINS</a:t>
                      </a:r>
                    </a:p>
                    <a:p>
                      <a:pPr algn="ctr"/>
                      <a:r>
                        <a:rPr lang="en-US" sz="2600" b="0" dirty="0"/>
                        <a:t>Make your grain foods </a:t>
                      </a:r>
                      <a:r>
                        <a:rPr lang="en-US" sz="2600" b="0" dirty="0"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en-US" sz="2600" b="0" dirty="0"/>
                        <a:t> whole grain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3200" b="1" dirty="0"/>
                        <a:t>DRINK WATER</a:t>
                      </a:r>
                    </a:p>
                    <a:p>
                      <a:pPr algn="ctr"/>
                      <a:r>
                        <a:rPr lang="en-US" sz="2400" b="0" dirty="0"/>
                        <a:t>Water, including most flavored waters, are 0-CAL</a:t>
                      </a:r>
                    </a:p>
                    <a:p>
                      <a:pPr algn="ctr"/>
                      <a:r>
                        <a:rPr lang="en-US" sz="2400" b="0" dirty="0"/>
                        <a:t>Stay hydrated and skip the added sugars with water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0469915"/>
                  </a:ext>
                </a:extLst>
              </a:tr>
              <a:tr h="1464734">
                <a:tc>
                  <a:txBody>
                    <a:bodyPr/>
                    <a:lstStyle/>
                    <a:p>
                      <a:pPr algn="ctr"/>
                      <a:r>
                        <a:rPr lang="en-US" sz="3200" b="1" dirty="0"/>
                        <a:t>CHOOSE LOW-FAT DAIRY</a:t>
                      </a:r>
                    </a:p>
                    <a:p>
                      <a:pPr algn="ctr"/>
                      <a:r>
                        <a:rPr lang="en-US" sz="2600" b="0" dirty="0"/>
                        <a:t>Dairy has a lot of saturated fat</a:t>
                      </a:r>
                    </a:p>
                    <a:p>
                      <a:pPr algn="ctr"/>
                      <a:r>
                        <a:rPr lang="en-US" sz="2600" b="0" dirty="0"/>
                        <a:t>Reach for the low-fat and plant-based option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3200" b="1" dirty="0"/>
                        <a:t>BUILD A HEALTHY EATING PATTERN</a:t>
                      </a:r>
                    </a:p>
                    <a:p>
                      <a:pPr algn="ctr"/>
                      <a:r>
                        <a:rPr lang="en-US" sz="2400" b="0" dirty="0"/>
                        <a:t>Make a plan and stick to it. Be prepared, and </a:t>
                      </a:r>
                    </a:p>
                    <a:p>
                      <a:pPr algn="ctr"/>
                      <a:r>
                        <a:rPr lang="en-US" sz="2400" b="0" dirty="0"/>
                        <a:t>Eat on a schedule to keep hunger away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32711449"/>
                  </a:ext>
                </a:extLst>
              </a:tr>
              <a:tr h="1464734">
                <a:tc>
                  <a:txBody>
                    <a:bodyPr/>
                    <a:lstStyle/>
                    <a:p>
                      <a:pPr algn="ctr"/>
                      <a:r>
                        <a:rPr lang="en-US" sz="3200" b="1" dirty="0"/>
                        <a:t>LOAD UP ON FRUIT &amp; VEGGIES</a:t>
                      </a:r>
                    </a:p>
                    <a:p>
                      <a:pPr algn="ctr"/>
                      <a:r>
                        <a:rPr lang="en-US" sz="2600" b="0" dirty="0"/>
                        <a:t>Half your plate = whole fruit and veggies</a:t>
                      </a:r>
                    </a:p>
                    <a:p>
                      <a:pPr algn="ctr"/>
                      <a:r>
                        <a:rPr lang="en-US" sz="2600" b="0" dirty="0"/>
                        <a:t>Variety is the spice of lif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3200" b="1" dirty="0"/>
                        <a:t>EVERYTHING YOU EAT MATTERS</a:t>
                      </a:r>
                    </a:p>
                    <a:p>
                      <a:pPr algn="ctr"/>
                      <a:r>
                        <a:rPr lang="en-US" sz="2400" b="0" dirty="0"/>
                        <a:t>Find the right mix that works for you</a:t>
                      </a:r>
                    </a:p>
                    <a:p>
                      <a:pPr algn="ctr"/>
                      <a:r>
                        <a:rPr lang="en-US" sz="2400" b="0" dirty="0"/>
                        <a:t>Turn small changes into BIG WINS!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0711380"/>
                  </a:ext>
                </a:extLst>
              </a:tr>
            </a:tbl>
          </a:graphicData>
        </a:graphic>
      </p:graphicFrame>
      <p:pic>
        <p:nvPicPr>
          <p:cNvPr id="23" name="Graphic 22" descr="Badge 1 outline">
            <a:extLst>
              <a:ext uri="{FF2B5EF4-FFF2-40B4-BE49-F238E27FC236}">
                <a16:creationId xmlns:a16="http://schemas.microsoft.com/office/drawing/2014/main" id="{1FE5B4B5-0C0F-416A-96B5-2E0A0A9F452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676400" y="2430999"/>
            <a:ext cx="914400" cy="914400"/>
          </a:xfrm>
          <a:prstGeom prst="rect">
            <a:avLst/>
          </a:prstGeom>
        </p:spPr>
      </p:pic>
      <p:pic>
        <p:nvPicPr>
          <p:cNvPr id="26" name="Graphic 25" descr="Badge with solid fill">
            <a:extLst>
              <a:ext uri="{FF2B5EF4-FFF2-40B4-BE49-F238E27FC236}">
                <a16:creationId xmlns:a16="http://schemas.microsoft.com/office/drawing/2014/main" id="{885EBA2B-A278-4EE0-8778-DE4E32DED4B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676400" y="3800747"/>
            <a:ext cx="914400" cy="914400"/>
          </a:xfrm>
          <a:prstGeom prst="rect">
            <a:avLst/>
          </a:prstGeom>
        </p:spPr>
      </p:pic>
      <p:pic>
        <p:nvPicPr>
          <p:cNvPr id="30" name="Graphic 29" descr="Badge 3 outline">
            <a:extLst>
              <a:ext uri="{FF2B5EF4-FFF2-40B4-BE49-F238E27FC236}">
                <a16:creationId xmlns:a16="http://schemas.microsoft.com/office/drawing/2014/main" id="{F8647BC8-3BC4-4364-926C-288B01FC00A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676400" y="5170496"/>
            <a:ext cx="914400" cy="914400"/>
          </a:xfrm>
          <a:prstGeom prst="rect">
            <a:avLst/>
          </a:prstGeom>
        </p:spPr>
      </p:pic>
      <p:pic>
        <p:nvPicPr>
          <p:cNvPr id="32" name="Graphic 31" descr="Badge 4 with solid fill">
            <a:extLst>
              <a:ext uri="{FF2B5EF4-FFF2-40B4-BE49-F238E27FC236}">
                <a16:creationId xmlns:a16="http://schemas.microsoft.com/office/drawing/2014/main" id="{92EF61FF-522B-4F36-AFF5-3E8CC0387EF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1676400" y="6521978"/>
            <a:ext cx="914400" cy="914400"/>
          </a:xfrm>
          <a:prstGeom prst="rect">
            <a:avLst/>
          </a:prstGeom>
        </p:spPr>
      </p:pic>
      <p:pic>
        <p:nvPicPr>
          <p:cNvPr id="34" name="Graphic 33" descr="Badge 5 outline">
            <a:extLst>
              <a:ext uri="{FF2B5EF4-FFF2-40B4-BE49-F238E27FC236}">
                <a16:creationId xmlns:a16="http://schemas.microsoft.com/office/drawing/2014/main" id="{4496FA69-9150-4F40-B79D-377C509CFEC4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1676400" y="7915089"/>
            <a:ext cx="914400" cy="914400"/>
          </a:xfrm>
          <a:prstGeom prst="rect">
            <a:avLst/>
          </a:prstGeom>
        </p:spPr>
      </p:pic>
      <p:pic>
        <p:nvPicPr>
          <p:cNvPr id="36" name="Graphic 35" descr="Badge 6 with solid fill">
            <a:extLst>
              <a:ext uri="{FF2B5EF4-FFF2-40B4-BE49-F238E27FC236}">
                <a16:creationId xmlns:a16="http://schemas.microsoft.com/office/drawing/2014/main" id="{1C2393FB-982C-414E-BDF8-D1B22F7F2007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9598829" y="2527622"/>
            <a:ext cx="914400" cy="914400"/>
          </a:xfrm>
          <a:prstGeom prst="rect">
            <a:avLst/>
          </a:prstGeom>
        </p:spPr>
      </p:pic>
      <p:pic>
        <p:nvPicPr>
          <p:cNvPr id="38" name="Graphic 37" descr="Badge 7 outline">
            <a:extLst>
              <a:ext uri="{FF2B5EF4-FFF2-40B4-BE49-F238E27FC236}">
                <a16:creationId xmlns:a16="http://schemas.microsoft.com/office/drawing/2014/main" id="{B4B0AB09-787E-4E7F-9865-9FEDFD93260F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9598829" y="3759086"/>
            <a:ext cx="914400" cy="914400"/>
          </a:xfrm>
          <a:prstGeom prst="rect">
            <a:avLst/>
          </a:prstGeom>
        </p:spPr>
      </p:pic>
      <p:pic>
        <p:nvPicPr>
          <p:cNvPr id="40" name="Graphic 39" descr="Badge 8 with solid fill">
            <a:extLst>
              <a:ext uri="{FF2B5EF4-FFF2-40B4-BE49-F238E27FC236}">
                <a16:creationId xmlns:a16="http://schemas.microsoft.com/office/drawing/2014/main" id="{31D0B1B4-99AC-4837-BB8C-1BA1F648A6EB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8"/>
              </a:ext>
            </a:extLst>
          </a:blip>
          <a:stretch>
            <a:fillRect/>
          </a:stretch>
        </p:blipFill>
        <p:spPr>
          <a:xfrm>
            <a:off x="9598829" y="5191133"/>
            <a:ext cx="914400" cy="914400"/>
          </a:xfrm>
          <a:prstGeom prst="rect">
            <a:avLst/>
          </a:prstGeom>
        </p:spPr>
      </p:pic>
      <p:pic>
        <p:nvPicPr>
          <p:cNvPr id="42" name="Graphic 41" descr="Badge 9 outline">
            <a:extLst>
              <a:ext uri="{FF2B5EF4-FFF2-40B4-BE49-F238E27FC236}">
                <a16:creationId xmlns:a16="http://schemas.microsoft.com/office/drawing/2014/main" id="{67E9E898-7915-412E-B61F-23B8BEC6F44E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20"/>
              </a:ext>
            </a:extLst>
          </a:blip>
          <a:stretch>
            <a:fillRect/>
          </a:stretch>
        </p:blipFill>
        <p:spPr>
          <a:xfrm>
            <a:off x="9623662" y="6623180"/>
            <a:ext cx="914400" cy="914400"/>
          </a:xfrm>
          <a:prstGeom prst="rect">
            <a:avLst/>
          </a:prstGeom>
        </p:spPr>
      </p:pic>
      <p:pic>
        <p:nvPicPr>
          <p:cNvPr id="46" name="Graphic 45" descr="Badge 10 with solid fill">
            <a:extLst>
              <a:ext uri="{FF2B5EF4-FFF2-40B4-BE49-F238E27FC236}">
                <a16:creationId xmlns:a16="http://schemas.microsoft.com/office/drawing/2014/main" id="{B7235D85-5257-4C1B-BABF-08BE371579A6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22"/>
              </a:ext>
            </a:extLst>
          </a:blip>
          <a:stretch>
            <a:fillRect/>
          </a:stretch>
        </p:blipFill>
        <p:spPr>
          <a:xfrm>
            <a:off x="9623662" y="7962688"/>
            <a:ext cx="914400" cy="91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757529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Changes I can mak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F2CE784-2A40-4CB2-8D1C-8CF36C75FC27}"/>
              </a:ext>
            </a:extLst>
          </p:cNvPr>
          <p:cNvSpPr txBox="1"/>
          <p:nvPr/>
        </p:nvSpPr>
        <p:spPr>
          <a:xfrm>
            <a:off x="1629256" y="2413655"/>
            <a:ext cx="14906144" cy="64633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What will I do to make the strategies for success work for me? (select all)</a:t>
            </a:r>
          </a:p>
          <a:p>
            <a:endParaRPr lang="en-US" sz="18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Choose healthy fats and avoid saturated fat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Stick to a healthy eating plan and schedule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Include a variety of foods every da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Eat different lean proteins at every meal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Replace processed foods with more whole fruits, vegetables, nuts, seeds and whole grain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Snack healthy with yogurt, unsalted nuts and nut butter, or fruit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Drink more water and less soda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Eat more fiber, like beans, peas, vegetables and whole grain cereal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Reduce sodium and season with herbs and spices instead of salt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All the abov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Other (discuss)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28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28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9218" name="Picture 2" descr="Why Enterprise SEO Needs a Champion">
            <a:extLst>
              <a:ext uri="{FF2B5EF4-FFF2-40B4-BE49-F238E27FC236}">
                <a16:creationId xmlns:a16="http://schemas.microsoft.com/office/drawing/2014/main" id="{77E00D8C-D5E9-43B6-8787-0468356D9B1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66"/>
          <a:stretch/>
        </p:blipFill>
        <p:spPr bwMode="auto">
          <a:xfrm>
            <a:off x="11277600" y="7150608"/>
            <a:ext cx="5676900" cy="31363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5908957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BD152DD6-B216-9B45-AA86-3A765B1A97E1}"/>
              </a:ext>
            </a:extLst>
          </p:cNvPr>
          <p:cNvSpPr txBox="1"/>
          <p:nvPr/>
        </p:nvSpPr>
        <p:spPr>
          <a:xfrm>
            <a:off x="1533679" y="1871844"/>
            <a:ext cx="10201121" cy="82176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 Regular" charset="-79"/>
                <a:cs typeface="Assistant Regular" charset="-79"/>
              </a:rPr>
              <a:t>Make a healthy meal! Choose the best options:</a:t>
            </a:r>
          </a:p>
          <a:p>
            <a:pPr marL="914400" lvl="1" indent="-457200">
              <a:buFont typeface="Wingdings" panose="05000000000000000000" pitchFamily="2" charset="2"/>
              <a:buChar char="Ø"/>
            </a:pPr>
            <a:r>
              <a:rPr lang="en-US" sz="4000" b="1" u="sng" dirty="0">
                <a:latin typeface="Assistant Regular" charset="-79"/>
                <a:cs typeface="Assistant Regular" charset="-79"/>
              </a:rPr>
              <a:t>Vegetable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French Fries with ketchup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Green salad w/ balsamic vinaigrette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Broccoli-Cheddar soup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Grilled peppers and onions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Black beans and salsa, or baked beans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Baked potato with drizzle of olive oil and chives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1 &amp; 3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2, 4,  5, &amp; 6</a:t>
            </a:r>
          </a:p>
          <a:p>
            <a:pPr lvl="2"/>
            <a:endParaRPr lang="en-US" sz="3200" b="1" dirty="0">
              <a:latin typeface="Assistant Regular" charset="-79"/>
              <a:cs typeface="Assistant Regular" charset="-79"/>
            </a:endParaRPr>
          </a:p>
          <a:p>
            <a:pPr marL="1371600" lvl="2" indent="-457200">
              <a:buFont typeface="Courier New" panose="02070309020205020404" pitchFamily="49" charset="0"/>
              <a:buChar char="o"/>
            </a:pPr>
            <a:endParaRPr lang="en-US" sz="3200" b="1" dirty="0">
              <a:latin typeface="Assistant Regular" charset="-79"/>
              <a:cs typeface="Assistant Regular" charset="-79"/>
            </a:endParaRPr>
          </a:p>
          <a:p>
            <a:pPr marL="1371600" lvl="2" indent="-457200">
              <a:buFont typeface="Courier New" panose="02070309020205020404" pitchFamily="49" charset="0"/>
              <a:buChar char="o"/>
            </a:pPr>
            <a:endParaRPr lang="en-US" sz="3200" b="1" dirty="0">
              <a:latin typeface="Assistant Regular" charset="-79"/>
              <a:cs typeface="Assistant Regular" charset="-79"/>
            </a:endParaRPr>
          </a:p>
        </p:txBody>
      </p: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50" y="-7248434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INTERACTIV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10242" name="Picture 2" descr="Tips for MyPlate">
            <a:extLst>
              <a:ext uri="{FF2B5EF4-FFF2-40B4-BE49-F238E27FC236}">
                <a16:creationId xmlns:a16="http://schemas.microsoft.com/office/drawing/2014/main" id="{CB0F01B2-5EE9-4E80-BBA4-8924080A089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77800" y="1777436"/>
            <a:ext cx="4810125" cy="33700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973812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BD152DD6-B216-9B45-AA86-3A765B1A97E1}"/>
              </a:ext>
            </a:extLst>
          </p:cNvPr>
          <p:cNvSpPr txBox="1"/>
          <p:nvPr/>
        </p:nvSpPr>
        <p:spPr>
          <a:xfrm>
            <a:off x="1533679" y="1871844"/>
            <a:ext cx="9380555" cy="6986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 Regular" charset="-79"/>
                <a:cs typeface="Assistant Regular" charset="-79"/>
              </a:rPr>
              <a:t>Make a healthy meal! Choose the best options:</a:t>
            </a:r>
          </a:p>
          <a:p>
            <a:pPr marL="914400" lvl="1" indent="-457200">
              <a:buFont typeface="Wingdings" panose="05000000000000000000" pitchFamily="2" charset="2"/>
              <a:buChar char="Ø"/>
            </a:pPr>
            <a:r>
              <a:rPr lang="en-US" sz="4000" b="1" u="sng" dirty="0">
                <a:latin typeface="Assistant Regular" charset="-79"/>
                <a:cs typeface="Assistant Regular" charset="-79"/>
              </a:rPr>
              <a:t>Fruit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Apple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Cocktail Cherries in syrup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Peach Pie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4 oz fresh squeezed OJ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Cherry Tomatoes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2 &amp; 3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1, 4, &amp; 5</a:t>
            </a:r>
          </a:p>
          <a:p>
            <a:pPr lvl="2"/>
            <a:endParaRPr lang="en-US" sz="3200" b="1" dirty="0">
              <a:latin typeface="Assistant Regular" charset="-79"/>
              <a:cs typeface="Assistant Regular" charset="-79"/>
            </a:endParaRPr>
          </a:p>
          <a:p>
            <a:pPr marL="1371600" lvl="2" indent="-457200">
              <a:buFont typeface="Courier New" panose="02070309020205020404" pitchFamily="49" charset="0"/>
              <a:buChar char="o"/>
            </a:pPr>
            <a:endParaRPr lang="en-US" sz="3200" b="1" dirty="0">
              <a:latin typeface="Assistant Regular" charset="-79"/>
              <a:cs typeface="Assistant Regular" charset="-79"/>
            </a:endParaRPr>
          </a:p>
          <a:p>
            <a:pPr marL="1371600" lvl="2" indent="-457200">
              <a:buFont typeface="Courier New" panose="02070309020205020404" pitchFamily="49" charset="0"/>
              <a:buChar char="o"/>
            </a:pPr>
            <a:endParaRPr lang="en-US" sz="3200" b="1" dirty="0">
              <a:latin typeface="Assistant Regular" charset="-79"/>
              <a:cs typeface="Assistant Regular" charset="-79"/>
            </a:endParaRPr>
          </a:p>
        </p:txBody>
      </p: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50" y="-7248434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INTERACTIV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10242" name="Picture 2" descr="Tips for MyPlate">
            <a:extLst>
              <a:ext uri="{FF2B5EF4-FFF2-40B4-BE49-F238E27FC236}">
                <a16:creationId xmlns:a16="http://schemas.microsoft.com/office/drawing/2014/main" id="{CB0F01B2-5EE9-4E80-BBA4-8924080A089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77800" y="1777436"/>
            <a:ext cx="4810125" cy="33700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9165693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BD152DD6-B216-9B45-AA86-3A765B1A97E1}"/>
              </a:ext>
            </a:extLst>
          </p:cNvPr>
          <p:cNvSpPr txBox="1"/>
          <p:nvPr/>
        </p:nvSpPr>
        <p:spPr>
          <a:xfrm>
            <a:off x="1533679" y="1871844"/>
            <a:ext cx="9380555" cy="7602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 Regular" charset="-79"/>
                <a:cs typeface="Assistant Regular" charset="-79"/>
              </a:rPr>
              <a:t>Make a healthy meal! Choose the best options:</a:t>
            </a:r>
          </a:p>
          <a:p>
            <a:pPr marL="914400" lvl="1" indent="-457200">
              <a:buFont typeface="Wingdings" panose="05000000000000000000" pitchFamily="2" charset="2"/>
              <a:buChar char="Ø"/>
            </a:pPr>
            <a:r>
              <a:rPr lang="en-US" sz="4000" b="1" u="sng" dirty="0">
                <a:latin typeface="Assistant Regular" charset="-79"/>
                <a:cs typeface="Assistant Regular" charset="-79"/>
              </a:rPr>
              <a:t>Grains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Frosted Flakes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Bran Flakes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Donuts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Brown Rice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Whole Wheat Pasta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Whole wheat bagels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1 &amp; 3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2, 4, 5, &amp; 6</a:t>
            </a:r>
          </a:p>
          <a:p>
            <a:pPr lvl="2"/>
            <a:endParaRPr lang="en-US" sz="3200" b="1" dirty="0">
              <a:latin typeface="Assistant Regular" charset="-79"/>
              <a:cs typeface="Assistant Regular" charset="-79"/>
            </a:endParaRPr>
          </a:p>
          <a:p>
            <a:pPr marL="1371600" lvl="2" indent="-457200">
              <a:buFont typeface="Courier New" panose="02070309020205020404" pitchFamily="49" charset="0"/>
              <a:buChar char="o"/>
            </a:pPr>
            <a:endParaRPr lang="en-US" sz="3200" b="1" dirty="0">
              <a:latin typeface="Assistant Regular" charset="-79"/>
              <a:cs typeface="Assistant Regular" charset="-79"/>
            </a:endParaRPr>
          </a:p>
          <a:p>
            <a:pPr marL="1371600" lvl="2" indent="-457200">
              <a:buFont typeface="Courier New" panose="02070309020205020404" pitchFamily="49" charset="0"/>
              <a:buChar char="o"/>
            </a:pPr>
            <a:endParaRPr lang="en-US" sz="3200" b="1" dirty="0">
              <a:latin typeface="Assistant Regular" charset="-79"/>
              <a:cs typeface="Assistant Regular" charset="-79"/>
            </a:endParaRPr>
          </a:p>
        </p:txBody>
      </p: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50" y="-7248434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INTERACTIV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10242" name="Picture 2" descr="Tips for MyPlate">
            <a:extLst>
              <a:ext uri="{FF2B5EF4-FFF2-40B4-BE49-F238E27FC236}">
                <a16:creationId xmlns:a16="http://schemas.microsoft.com/office/drawing/2014/main" id="{CB0F01B2-5EE9-4E80-BBA4-8924080A089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77800" y="1777436"/>
            <a:ext cx="4810125" cy="33700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9731730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BD152DD6-B216-9B45-AA86-3A765B1A97E1}"/>
              </a:ext>
            </a:extLst>
          </p:cNvPr>
          <p:cNvSpPr txBox="1"/>
          <p:nvPr/>
        </p:nvSpPr>
        <p:spPr>
          <a:xfrm>
            <a:off x="1533679" y="1871844"/>
            <a:ext cx="9380555" cy="82176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 Regular" charset="-79"/>
                <a:cs typeface="Assistant Regular" charset="-79"/>
              </a:rPr>
              <a:t>Make a healthy meal! Choose the best options:</a:t>
            </a:r>
          </a:p>
          <a:p>
            <a:pPr marL="914400" lvl="1" indent="-457200">
              <a:buFont typeface="Wingdings" panose="05000000000000000000" pitchFamily="2" charset="2"/>
              <a:buChar char="Ø"/>
            </a:pPr>
            <a:r>
              <a:rPr lang="en-US" sz="4000" b="1" u="sng" dirty="0">
                <a:latin typeface="Assistant Regular" charset="-79"/>
                <a:cs typeface="Assistant Regular" charset="-79"/>
              </a:rPr>
              <a:t>Protein Foods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Burger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Tuna salad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Black beans or baked beans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Lean chicken breast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Bacon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Peanut Butter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Walnuts, Almonds, and Pecans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1 &amp; 5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2, 3, 4, 6, &amp; 7</a:t>
            </a:r>
          </a:p>
          <a:p>
            <a:pPr lvl="2"/>
            <a:endParaRPr lang="en-US" sz="3200" b="1" dirty="0">
              <a:latin typeface="Assistant Regular" charset="-79"/>
              <a:cs typeface="Assistant Regular" charset="-79"/>
            </a:endParaRPr>
          </a:p>
          <a:p>
            <a:pPr marL="1371600" lvl="2" indent="-457200">
              <a:buFont typeface="Courier New" panose="02070309020205020404" pitchFamily="49" charset="0"/>
              <a:buChar char="o"/>
            </a:pPr>
            <a:endParaRPr lang="en-US" sz="3200" b="1" dirty="0">
              <a:latin typeface="Assistant Regular" charset="-79"/>
              <a:cs typeface="Assistant Regular" charset="-79"/>
            </a:endParaRPr>
          </a:p>
          <a:p>
            <a:pPr marL="1371600" lvl="2" indent="-457200">
              <a:buFont typeface="Courier New" panose="02070309020205020404" pitchFamily="49" charset="0"/>
              <a:buChar char="o"/>
            </a:pPr>
            <a:endParaRPr lang="en-US" sz="3200" b="1" dirty="0">
              <a:latin typeface="Assistant Regular" charset="-79"/>
              <a:cs typeface="Assistant Regular" charset="-79"/>
            </a:endParaRPr>
          </a:p>
        </p:txBody>
      </p: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50" y="-7248434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INTERACTIV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10242" name="Picture 2" descr="Tips for MyPlate">
            <a:extLst>
              <a:ext uri="{FF2B5EF4-FFF2-40B4-BE49-F238E27FC236}">
                <a16:creationId xmlns:a16="http://schemas.microsoft.com/office/drawing/2014/main" id="{CB0F01B2-5EE9-4E80-BBA4-8924080A089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77800" y="1777436"/>
            <a:ext cx="4810125" cy="33700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5118199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BD152DD6-B216-9B45-AA86-3A765B1A97E1}"/>
              </a:ext>
            </a:extLst>
          </p:cNvPr>
          <p:cNvSpPr txBox="1"/>
          <p:nvPr/>
        </p:nvSpPr>
        <p:spPr>
          <a:xfrm>
            <a:off x="1533679" y="1871844"/>
            <a:ext cx="9380555" cy="58785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 Regular" charset="-79"/>
                <a:cs typeface="Assistant Regular" charset="-79"/>
              </a:rPr>
              <a:t>Make a healthy meal! Choose the best options:</a:t>
            </a:r>
          </a:p>
          <a:p>
            <a:pPr marL="914400" lvl="1" indent="-457200">
              <a:buFont typeface="Wingdings" panose="05000000000000000000" pitchFamily="2" charset="2"/>
              <a:buChar char="Ø"/>
            </a:pPr>
            <a:r>
              <a:rPr lang="en-US" sz="4000" b="1" u="sng" dirty="0">
                <a:latin typeface="Assistant Regular" charset="-79"/>
                <a:cs typeface="Assistant Regular" charset="-79"/>
              </a:rPr>
              <a:t>Dairy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Alfredo sauce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Low-fat yogurt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Soy-milk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Low-fat cottage cheese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1 &amp; 4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r>
              <a:rPr lang="en-US" sz="4000" b="1" dirty="0">
                <a:latin typeface="Assistant Regular" charset="-79"/>
                <a:cs typeface="Assistant Regular" charset="-79"/>
              </a:rPr>
              <a:t>2, 3, &amp; 4</a:t>
            </a:r>
          </a:p>
          <a:p>
            <a:pPr marL="1371600" lvl="2" indent="-457200">
              <a:buFont typeface="Courier New" panose="02070309020205020404" pitchFamily="49" charset="0"/>
              <a:buChar char="o"/>
            </a:pPr>
            <a:endParaRPr lang="en-US" sz="3200" b="1" dirty="0">
              <a:latin typeface="Assistant Regular" charset="-79"/>
              <a:cs typeface="Assistant Regular" charset="-79"/>
            </a:endParaRPr>
          </a:p>
          <a:p>
            <a:pPr marL="1371600" lvl="2" indent="-457200">
              <a:buFont typeface="Courier New" panose="02070309020205020404" pitchFamily="49" charset="0"/>
              <a:buChar char="o"/>
            </a:pPr>
            <a:endParaRPr lang="en-US" sz="3200" b="1" dirty="0">
              <a:latin typeface="Assistant Regular" charset="-79"/>
              <a:cs typeface="Assistant Regular" charset="-79"/>
            </a:endParaRPr>
          </a:p>
        </p:txBody>
      </p: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50" y="-7248434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INTERACTIV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10242" name="Picture 2" descr="Tips for MyPlate">
            <a:extLst>
              <a:ext uri="{FF2B5EF4-FFF2-40B4-BE49-F238E27FC236}">
                <a16:creationId xmlns:a16="http://schemas.microsoft.com/office/drawing/2014/main" id="{CB0F01B2-5EE9-4E80-BBA4-8924080A089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77800" y="1777436"/>
            <a:ext cx="4810125" cy="33700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38083147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2098510"/>
            <a:ext cx="16543470" cy="58785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Keeping Track of What You Eat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rack those meals and take your weight EVERYDAY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onitor your progress and identify areas for improvement towards YOUR GOAL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sk yourself- can I choose a healthier choice today?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When shopping, snacking, or planning meals each time ask yourself what you can improve</a:t>
            </a:r>
          </a:p>
          <a:p>
            <a:pPr marL="1428750" lvl="2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EXAMPLE: Swap from frying to baking a potato</a:t>
            </a:r>
          </a:p>
          <a:p>
            <a:pPr marL="1428750" lvl="2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EXAMPLE: Swap from soda to flavored seltzer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Give your recipes and  meals a healthy make-over!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Pages 12-14 of the handout gives tips to improve your meal plan!</a:t>
            </a:r>
          </a:p>
          <a:p>
            <a:pPr marL="1371600" lvl="2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Healthier snacks, ways to season food to make it taste delicious, cooking methods and more!</a:t>
            </a: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ut it into Practic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7170" name="Picture 2" descr="Light Bulb Drawing — How To Draw A Light Bulb Step By Step">
            <a:extLst>
              <a:ext uri="{FF2B5EF4-FFF2-40B4-BE49-F238E27FC236}">
                <a16:creationId xmlns:a16="http://schemas.microsoft.com/office/drawing/2014/main" id="{717510DC-DED5-4840-BA18-B4B5E106570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/>
        </p:blipFill>
        <p:spPr bwMode="auto">
          <a:xfrm>
            <a:off x="1617209" y="7980645"/>
            <a:ext cx="1809750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5BB29B-4DD6-4C05-B71D-A7C30F5AF4CA}"/>
              </a:ext>
            </a:extLst>
          </p:cNvPr>
          <p:cNvSpPr txBox="1"/>
          <p:nvPr/>
        </p:nvSpPr>
        <p:spPr>
          <a:xfrm>
            <a:off x="3690518" y="8494466"/>
            <a:ext cx="12768682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REMEMBER THIS WEEK’S TIP: </a:t>
            </a:r>
            <a:r>
              <a:rPr lang="en-US" sz="3200" b="1" i="1" u="sng" dirty="0">
                <a:solidFill>
                  <a:srgbClr val="FF0000"/>
                </a:solidFill>
              </a:rPr>
              <a:t>VARY THOSE VEGGIES!</a:t>
            </a:r>
          </a:p>
          <a:p>
            <a:r>
              <a:rPr lang="en-US" sz="2800" dirty="0"/>
              <a:t>Try something new this week, or if you can change it up every meal!</a:t>
            </a:r>
          </a:p>
          <a:p>
            <a:r>
              <a:rPr lang="en-US" sz="2800" dirty="0"/>
              <a:t>Choose veggies high in protein and fiber to satisfy you even longer with fewer calories!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41154793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1870958"/>
            <a:ext cx="16543470" cy="477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For next week: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Go on </a:t>
            </a:r>
            <a:r>
              <a:rPr lang="en-US" sz="3200">
                <a:latin typeface="Assistant" pitchFamily="2" charset="-79"/>
                <a:cs typeface="Assistant" pitchFamily="2" charset="-79"/>
              </a:rPr>
              <a:t>a new food </a:t>
            </a:r>
            <a:r>
              <a:rPr lang="en-US" sz="3200" dirty="0">
                <a:latin typeface="Assistant" pitchFamily="2" charset="-79"/>
                <a:cs typeface="Assistant" pitchFamily="2" charset="-79"/>
              </a:rPr>
              <a:t>adventure, keep track of the new foods you tried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2.   Track meals and </a:t>
            </a:r>
            <a:r>
              <a:rPr lang="en-US" sz="3200" b="1" u="sng" dirty="0">
                <a:latin typeface="Assistant" pitchFamily="2" charset="-79"/>
                <a:cs typeface="Assistant" pitchFamily="2" charset="-79"/>
              </a:rPr>
              <a:t>Weigh every day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Make 2,000 steps of your 5,000 steps brisk walking</a:t>
            </a:r>
            <a:endParaRPr lang="en-US" sz="30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mail the Intervention Team and Review the </a:t>
            </a:r>
            <a:r>
              <a:rPr lang="en-US" sz="3200" dirty="0" err="1">
                <a:latin typeface="Assistant" pitchFamily="2" charset="-79"/>
                <a:cs typeface="Assistant" pitchFamily="2" charset="-79"/>
              </a:rPr>
              <a:t>Repsonse</a:t>
            </a:r>
            <a:r>
              <a:rPr lang="en-US" sz="3200" dirty="0">
                <a:latin typeface="Assistant" pitchFamily="2" charset="-79"/>
                <a:cs typeface="Assistant" pitchFamily="2" charset="-79"/>
              </a:rPr>
              <a:t>!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Question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8194" name="Picture 2" descr="8 Steps to a Healthier Heart : Food Network | Food Network">
            <a:extLst>
              <a:ext uri="{FF2B5EF4-FFF2-40B4-BE49-F238E27FC236}">
                <a16:creationId xmlns:a16="http://schemas.microsoft.com/office/drawing/2014/main" id="{549B7221-92A9-43CA-A5FB-72D90E6CA0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095" y="7701000"/>
            <a:ext cx="2971800" cy="22259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C0810DF-5638-45AB-8697-9BF28FA38C5F}"/>
              </a:ext>
            </a:extLst>
          </p:cNvPr>
          <p:cNvSpPr txBox="1"/>
          <p:nvPr/>
        </p:nvSpPr>
        <p:spPr>
          <a:xfrm>
            <a:off x="4599895" y="7962900"/>
            <a:ext cx="11554505" cy="1508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FOOD FOR THOUGHT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Build on successes, no one is perfect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Focus on what is working, look for creative solutions</a:t>
            </a:r>
          </a:p>
        </p:txBody>
      </p:sp>
    </p:spTree>
    <p:extLst>
      <p:ext uri="{BB962C8B-B14F-4D97-AF65-F5344CB8AC3E}">
        <p14:creationId xmlns:p14="http://schemas.microsoft.com/office/powerpoint/2010/main" val="4098137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Group Opening Discussion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15130" y="1746935"/>
            <a:ext cx="14668500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dirty="0">
                <a:latin typeface="Assistant Regular" charset="-79"/>
                <a:cs typeface="Assistant Regular" charset="-79"/>
              </a:rPr>
              <a:t>WELCOME BACK! </a:t>
            </a:r>
            <a:r>
              <a:rPr lang="en-US" sz="3200" b="1" u="sng" dirty="0">
                <a:latin typeface="Assistant Regular" charset="-79"/>
                <a:cs typeface="Assistant Regular" charset="-79"/>
              </a:rPr>
              <a:t>HOW WAS LAST WEEK</a:t>
            </a:r>
            <a:r>
              <a:rPr lang="en-US" sz="3200" dirty="0">
                <a:latin typeface="Assistant Regular" charset="-79"/>
                <a:cs typeface="Assistant Regular" charset="-79"/>
              </a:rPr>
              <a:t>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track every meal?</a:t>
            </a:r>
          </a:p>
          <a:p>
            <a:pPr marL="514350" indent="-514350">
              <a:buFont typeface="+mj-lt"/>
              <a:buAutoNum type="arabicPeriod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stick to your fat and calorie targets?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Did you weigh every day, &amp; record your weight today?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get 5,000 steps a day?</a:t>
            </a:r>
            <a:endParaRPr lang="en-US" sz="30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email the Intervention team and review the response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hat were your unique challenges and successes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1026" name="Picture 2" descr="Different ways of asking 'how are you?' in English.">
            <a:extLst>
              <a:ext uri="{FF2B5EF4-FFF2-40B4-BE49-F238E27FC236}">
                <a16:creationId xmlns:a16="http://schemas.microsoft.com/office/drawing/2014/main" id="{05614FE7-C505-4615-8A17-CBB7671F67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81635" y="1857730"/>
            <a:ext cx="5943354" cy="2971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phic 4" descr="Bell with solid fill">
            <a:extLst>
              <a:ext uri="{FF2B5EF4-FFF2-40B4-BE49-F238E27FC236}">
                <a16:creationId xmlns:a16="http://schemas.microsoft.com/office/drawing/2014/main" id="{7678B0BE-D0A3-418B-A68D-CF0D9528589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3516903" y="8479901"/>
            <a:ext cx="914400" cy="914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B74A0A-BC47-437A-AE76-BF9A443303E5}"/>
              </a:ext>
            </a:extLst>
          </p:cNvPr>
          <p:cNvSpPr txBox="1"/>
          <p:nvPr/>
        </p:nvSpPr>
        <p:spPr>
          <a:xfrm>
            <a:off x="14478000" y="8429270"/>
            <a:ext cx="2895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</a:rPr>
              <a:t>REMINDER: CHARGE YOUR FITBIT &amp; SCALE DURING THIS MEETING!</a:t>
            </a:r>
          </a:p>
        </p:txBody>
      </p:sp>
    </p:spTree>
    <p:extLst>
      <p:ext uri="{BB962C8B-B14F-4D97-AF65-F5344CB8AC3E}">
        <p14:creationId xmlns:p14="http://schemas.microsoft.com/office/powerpoint/2010/main" val="3752669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en did you eat the most fat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29256" y="2367826"/>
            <a:ext cx="10479651" cy="40318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Which meal had the most fat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Breakfast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Lunch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nner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nacks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15F599F-1C10-4D78-B583-3855FC96B18E}"/>
              </a:ext>
            </a:extLst>
          </p:cNvPr>
          <p:cNvSpPr txBox="1"/>
          <p:nvPr/>
        </p:nvSpPr>
        <p:spPr>
          <a:xfrm>
            <a:off x="2112526" y="8933563"/>
            <a:ext cx="154686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IM FOR SUCCESS </a:t>
            </a:r>
          </a:p>
          <a:p>
            <a:r>
              <a:rPr lang="en-US" sz="2000" dirty="0"/>
              <a:t>Figuring out where you are blowing your budget can help make you AWARE of which meal needs the most creativity to help you stay in CONTROL.</a:t>
            </a:r>
          </a:p>
          <a:p>
            <a:endParaRPr lang="en-US" sz="2000" dirty="0"/>
          </a:p>
        </p:txBody>
      </p:sp>
      <p:pic>
        <p:nvPicPr>
          <p:cNvPr id="14" name="Graphic 13" descr="Bullseye outline">
            <a:extLst>
              <a:ext uri="{FF2B5EF4-FFF2-40B4-BE49-F238E27FC236}">
                <a16:creationId xmlns:a16="http://schemas.microsoft.com/office/drawing/2014/main" id="{5B8093DA-18FA-4818-A56E-621677A8905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07984" y="8756910"/>
            <a:ext cx="1380593" cy="1380593"/>
          </a:xfrm>
          <a:prstGeom prst="rect">
            <a:avLst/>
          </a:prstGeom>
        </p:spPr>
      </p:pic>
      <p:pic>
        <p:nvPicPr>
          <p:cNvPr id="1026" name="Picture 2" descr="15 Healthy Meals That'll Fill You Up Without Weighing You Down - Once Upon  a Chef">
            <a:extLst>
              <a:ext uri="{FF2B5EF4-FFF2-40B4-BE49-F238E27FC236}">
                <a16:creationId xmlns:a16="http://schemas.microsoft.com/office/drawing/2014/main" id="{DF1CC007-B441-44A9-BB6B-1CDF4898552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4000" y="2223910"/>
            <a:ext cx="3704744" cy="50100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281020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How did you successfully reduce fat/calorie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29256" y="2107066"/>
            <a:ext cx="10479651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What worked for you this week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ating more fruit/vegetables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Cooking more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Bringing healthy food with m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eal planning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nacking les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Filling up on high-fiber food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kipping junk food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ther (discuss)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ll the Abov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15F599F-1C10-4D78-B583-3855FC96B18E}"/>
              </a:ext>
            </a:extLst>
          </p:cNvPr>
          <p:cNvSpPr txBox="1"/>
          <p:nvPr/>
        </p:nvSpPr>
        <p:spPr>
          <a:xfrm>
            <a:off x="2112526" y="8933563"/>
            <a:ext cx="14803874" cy="1508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IM FOR SUCCESS </a:t>
            </a:r>
          </a:p>
          <a:p>
            <a:r>
              <a:rPr lang="en-US" sz="2400" dirty="0"/>
              <a:t>There are lots of ways you can support your goals, you can even use different strategies on different days. </a:t>
            </a:r>
          </a:p>
          <a:p>
            <a:r>
              <a:rPr lang="en-US" sz="2400" dirty="0"/>
              <a:t>It is all about finding what works for you!</a:t>
            </a:r>
          </a:p>
          <a:p>
            <a:endParaRPr lang="en-US" sz="2000" dirty="0"/>
          </a:p>
        </p:txBody>
      </p:sp>
      <p:pic>
        <p:nvPicPr>
          <p:cNvPr id="14" name="Graphic 13" descr="Bullseye outline">
            <a:extLst>
              <a:ext uri="{FF2B5EF4-FFF2-40B4-BE49-F238E27FC236}">
                <a16:creationId xmlns:a16="http://schemas.microsoft.com/office/drawing/2014/main" id="{5B8093DA-18FA-4818-A56E-621677A8905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07984" y="8756910"/>
            <a:ext cx="1380593" cy="1380593"/>
          </a:xfrm>
          <a:prstGeom prst="rect">
            <a:avLst/>
          </a:prstGeom>
        </p:spPr>
      </p:pic>
      <p:pic>
        <p:nvPicPr>
          <p:cNvPr id="2050" name="Picture 2" descr="All-new salads to try before summer's gone">
            <a:extLst>
              <a:ext uri="{FF2B5EF4-FFF2-40B4-BE49-F238E27FC236}">
                <a16:creationId xmlns:a16="http://schemas.microsoft.com/office/drawing/2014/main" id="{35E72A4D-658B-4897-8510-50E7ECDADE6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23444" y="2647950"/>
            <a:ext cx="7486650" cy="4991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240511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Conscious Eating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ADEC6BD-BF5C-49E5-BAC2-4830AC5FAC3C}"/>
              </a:ext>
            </a:extLst>
          </p:cNvPr>
          <p:cNvSpPr txBox="1"/>
          <p:nvPr/>
        </p:nvSpPr>
        <p:spPr>
          <a:xfrm>
            <a:off x="1629256" y="1877145"/>
            <a:ext cx="11019944" cy="83099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u="sng" dirty="0"/>
              <a:t>Make eating the main attraction</a:t>
            </a:r>
          </a:p>
          <a:p>
            <a:pPr marL="914400" lvl="1" indent="-457200">
              <a:buFontTx/>
              <a:buChar char="-"/>
            </a:pPr>
            <a:r>
              <a:rPr lang="en-US" sz="3000" dirty="0"/>
              <a:t>Plan ahead</a:t>
            </a:r>
          </a:p>
          <a:p>
            <a:pPr marL="914400" lvl="1" indent="-457200">
              <a:buFontTx/>
              <a:buChar char="-"/>
            </a:pPr>
            <a:r>
              <a:rPr lang="en-US" sz="3000" dirty="0"/>
              <a:t>Stick to an eating schedule</a:t>
            </a:r>
          </a:p>
          <a:p>
            <a:pPr marL="914400" lvl="1" indent="-457200">
              <a:buFontTx/>
              <a:buChar char="-"/>
            </a:pPr>
            <a:r>
              <a:rPr lang="en-US" sz="3000" dirty="0"/>
              <a:t>Eat slowly: take intentional bites, make intentional pauses, and give yourself intentional portions</a:t>
            </a:r>
          </a:p>
          <a:p>
            <a:pPr marL="914400" lvl="1" indent="-457200">
              <a:buFontTx/>
              <a:buChar char="-"/>
            </a:pPr>
            <a:r>
              <a:rPr lang="en-US" sz="3000" dirty="0"/>
              <a:t>Eat at the table, or sit somewhere to focus on your meal</a:t>
            </a:r>
          </a:p>
          <a:p>
            <a:pPr marL="914400" lvl="1" indent="-457200">
              <a:buFontTx/>
              <a:buChar char="-"/>
            </a:pPr>
            <a:endParaRPr lang="en-US" sz="2000" dirty="0"/>
          </a:p>
          <a:p>
            <a:r>
              <a:rPr lang="en-US" sz="3200" b="1" u="sng" dirty="0"/>
              <a:t>Compose healthy meal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½ your plate fruit and vegetables</a:t>
            </a:r>
          </a:p>
          <a:p>
            <a:pPr marL="914400" lvl="1" indent="-457200">
              <a:buFont typeface="Wingdings" panose="05000000000000000000" pitchFamily="2" charset="2"/>
              <a:buChar char="Ø"/>
            </a:pPr>
            <a:r>
              <a:rPr lang="en-US" sz="3000" dirty="0"/>
              <a:t>A big serving of broccoli and an apple, or oranges in a big salad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¼ of your plate should be WHOLE Grains</a:t>
            </a:r>
          </a:p>
          <a:p>
            <a:pPr marL="914400" lvl="1" indent="-457200">
              <a:buFont typeface="Wingdings" panose="05000000000000000000" pitchFamily="2" charset="2"/>
              <a:buChar char="Ø"/>
            </a:pPr>
            <a:r>
              <a:rPr lang="en-US" sz="3000" dirty="0"/>
              <a:t>Like whole grain Bran Flakes, or steel cut oats for breakfast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¼ of your plate lean protein</a:t>
            </a:r>
          </a:p>
          <a:p>
            <a:pPr marL="914400" lvl="1" indent="-457200">
              <a:buFont typeface="Wingdings" panose="05000000000000000000" pitchFamily="2" charset="2"/>
              <a:buChar char="Ø"/>
            </a:pPr>
            <a:r>
              <a:rPr lang="en-US" sz="3000" dirty="0"/>
              <a:t>Like bean chili, or grilled chicken breast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3 servings of dairy  day</a:t>
            </a:r>
          </a:p>
          <a:p>
            <a:pPr marL="914400" lvl="1" indent="-457200">
              <a:buFont typeface="Wingdings" panose="05000000000000000000" pitchFamily="2" charset="2"/>
              <a:buChar char="Ø"/>
            </a:pPr>
            <a:r>
              <a:rPr lang="en-US" sz="3000" dirty="0"/>
              <a:t>Like low-fat yogurt or fortified soy milk in your breakfast cereal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LIMIT saturated fats, added sugar, and sodium</a:t>
            </a:r>
          </a:p>
          <a:p>
            <a:pPr marL="914400" lvl="1" indent="-457200">
              <a:buFontTx/>
              <a:buChar char="-"/>
            </a:pPr>
            <a:endParaRPr lang="en-US" sz="3000" dirty="0"/>
          </a:p>
        </p:txBody>
      </p:sp>
      <p:pic>
        <p:nvPicPr>
          <p:cNvPr id="3074" name="Picture 2" descr="My plate Images, Stock Photos &amp; Vectors | Shutterstock">
            <a:extLst>
              <a:ext uri="{FF2B5EF4-FFF2-40B4-BE49-F238E27FC236}">
                <a16:creationId xmlns:a16="http://schemas.microsoft.com/office/drawing/2014/main" id="{30717B07-A115-43CE-ADAF-06B60C98D67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572"/>
          <a:stretch/>
        </p:blipFill>
        <p:spPr bwMode="auto">
          <a:xfrm>
            <a:off x="12437272" y="3695700"/>
            <a:ext cx="5200650" cy="3962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654443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Fruit  -- 1-2 cups a day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1FEE5CC-E039-4F19-B498-2B394F5D5FEB}"/>
              </a:ext>
            </a:extLst>
          </p:cNvPr>
          <p:cNvSpPr txBox="1"/>
          <p:nvPr/>
        </p:nvSpPr>
        <p:spPr>
          <a:xfrm>
            <a:off x="1676400" y="2171700"/>
            <a:ext cx="15011400" cy="31700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Delicious, and so many to choose from!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Whole fruits are the best, but they can be FRESH, FROZEN, CANNED, or DRIED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/>
              <a:t>If canned, make sure they aren’t in JUICE or SYRUP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/>
              <a:t>Enjoy 100% fruit juice in small amounts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/>
              <a:t>Limit fruity desserts and drinks that are more flavoring and sugar than fruit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endParaRPr lang="en-US" sz="2400" dirty="0"/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2400" dirty="0"/>
          </a:p>
        </p:txBody>
      </p:sp>
      <p:pic>
        <p:nvPicPr>
          <p:cNvPr id="4102" name="Picture 6">
            <a:extLst>
              <a:ext uri="{FF2B5EF4-FFF2-40B4-BE49-F238E27FC236}">
                <a16:creationId xmlns:a16="http://schemas.microsoft.com/office/drawing/2014/main" id="{4D5B2489-23C1-4E6F-9860-4880BDD203C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8600" y="4686300"/>
            <a:ext cx="10896600" cy="5448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688956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Vegetables  -- 2-3 cups a day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1FEE5CC-E039-4F19-B498-2B394F5D5FEB}"/>
              </a:ext>
            </a:extLst>
          </p:cNvPr>
          <p:cNvSpPr txBox="1"/>
          <p:nvPr/>
        </p:nvSpPr>
        <p:spPr>
          <a:xfrm>
            <a:off x="1638300" y="2004192"/>
            <a:ext cx="15963900" cy="24314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Versatile, filling, and so many ways to eat them!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Change them up, try something new every week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FRESH, FROZEN, CANNED, DRIED or JUICE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/>
              <a:t>Limit fried, and watch out for salty, cheesy, or creamy veggies that sneakily add more calories and fat</a:t>
            </a:r>
            <a:endParaRPr lang="en-US" sz="2400" dirty="0"/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2400" dirty="0"/>
          </a:p>
        </p:txBody>
      </p:sp>
      <p:pic>
        <p:nvPicPr>
          <p:cNvPr id="5122" name="Picture 2" descr="Fresh fruits and vegetables Assortment of  fresh fruits and vegetables vegetables stock pictures, royalty-free photos &amp; images">
            <a:extLst>
              <a:ext uri="{FF2B5EF4-FFF2-40B4-BE49-F238E27FC236}">
                <a16:creationId xmlns:a16="http://schemas.microsoft.com/office/drawing/2014/main" id="{E82950BE-B767-4FC3-94B7-1617C4DEB87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0780" y="4091808"/>
            <a:ext cx="9258300" cy="6172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2" descr="Light Bulb Drawing — How To Draw A Light Bulb Step By Step">
            <a:extLst>
              <a:ext uri="{FF2B5EF4-FFF2-40B4-BE49-F238E27FC236}">
                <a16:creationId xmlns:a16="http://schemas.microsoft.com/office/drawing/2014/main" id="{6B4C1050-734E-41BB-B1E7-A24606B9F51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/>
        </p:blipFill>
        <p:spPr bwMode="auto">
          <a:xfrm>
            <a:off x="11249325" y="6515100"/>
            <a:ext cx="1809750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5163266D-E4B7-43DB-9596-2862F03CD390}"/>
              </a:ext>
            </a:extLst>
          </p:cNvPr>
          <p:cNvSpPr txBox="1"/>
          <p:nvPr/>
        </p:nvSpPr>
        <p:spPr>
          <a:xfrm>
            <a:off x="13182309" y="4332897"/>
            <a:ext cx="4264094" cy="58169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THIS WEEK’S TIP: </a:t>
            </a:r>
          </a:p>
          <a:p>
            <a:r>
              <a:rPr lang="en-US" sz="3200" b="1" i="1" u="sng" dirty="0">
                <a:solidFill>
                  <a:srgbClr val="FF0000"/>
                </a:solidFill>
              </a:rPr>
              <a:t>Vary those veggies!</a:t>
            </a:r>
          </a:p>
          <a:p>
            <a:r>
              <a:rPr lang="en-US" sz="2800" dirty="0"/>
              <a:t>Can you name all the veggies in this picture?</a:t>
            </a:r>
          </a:p>
          <a:p>
            <a:r>
              <a:rPr lang="en-US" sz="2800" dirty="0"/>
              <a:t>Veggies are affordable, filling, low fat, and low calorie and there are so many to try. Load up your grocery cart with your </a:t>
            </a:r>
            <a:r>
              <a:rPr lang="en-US" sz="2800" dirty="0" err="1"/>
              <a:t>faves</a:t>
            </a:r>
            <a:r>
              <a:rPr lang="en-US" sz="2800" dirty="0"/>
              <a:t> but keep your eye out for something new to try this week, it could become a new favorite!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82954526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ole Grains- 3 ounces a day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07E4156-BB74-4F6B-99B5-488D86221CA7}"/>
              </a:ext>
            </a:extLst>
          </p:cNvPr>
          <p:cNvSpPr txBox="1"/>
          <p:nvPr/>
        </p:nvSpPr>
        <p:spPr>
          <a:xfrm>
            <a:off x="1638300" y="2004192"/>
            <a:ext cx="15963900" cy="4339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Hearty, filling, and comforting!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Whole grains are tastier and more filling too!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200" dirty="0"/>
              <a:t>Aim for 3 ounces a day (the dry weight)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1 ounce of dry whole-wheat pasta, brown rice, steel cut oats, or quinoa is about ½ cup cooked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1 ounce is 1 slice of whole-grain bread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/>
              <a:t>Beware of sneaky added sugar and fat like in white bread, donuts, fried tortilla, and granola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/>
              <a:t>Choose HIGH fiber cereals, like: Fiber One Original, All Bran, Trader Joes High Fiber Cereal</a:t>
            </a:r>
            <a:endParaRPr lang="en-US" sz="2400" dirty="0"/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2400" dirty="0"/>
          </a:p>
        </p:txBody>
      </p:sp>
      <p:pic>
        <p:nvPicPr>
          <p:cNvPr id="6146" name="Picture 2">
            <a:extLst>
              <a:ext uri="{FF2B5EF4-FFF2-40B4-BE49-F238E27FC236}">
                <a16:creationId xmlns:a16="http://schemas.microsoft.com/office/drawing/2014/main" id="{CC9BED5E-6AB7-449D-926D-E801C6121DA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420"/>
          <a:stretch/>
        </p:blipFill>
        <p:spPr bwMode="auto">
          <a:xfrm>
            <a:off x="5688053" y="5986126"/>
            <a:ext cx="7958420" cy="39626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63735046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Lean Protein Foods- 5 ounces a day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07E4156-BB74-4F6B-99B5-488D86221CA7}"/>
              </a:ext>
            </a:extLst>
          </p:cNvPr>
          <p:cNvSpPr txBox="1"/>
          <p:nvPr/>
        </p:nvSpPr>
        <p:spPr>
          <a:xfrm>
            <a:off x="1640826" y="1866276"/>
            <a:ext cx="15963900" cy="4278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dirty="0"/>
              <a:t>Keeps you from feeling hungry longer!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Go on a protein adventure: beans, peas, nuts, seeds, egg whites, fish, poultr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200" dirty="0"/>
              <a:t>1 ounce of cooked meat or 2 egg whites = 1 ounce towards a serving of protein food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1/4 cup beans, tofu  or 2 tablespoons of hummus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1/2 split pea or lentil soup 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/>
              <a:t>Red and processed meat has a lot of saturated fat, sodium, and even added sugar!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/>
              <a:t>Remember to trim the fat and remove the skin from your meats!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2800" dirty="0"/>
              <a:t>Use low-fat cooking methods: baking, grilling, steaming, roasting, and microwaving </a:t>
            </a:r>
            <a:endParaRPr lang="en-US" sz="2400" dirty="0"/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2400" dirty="0"/>
          </a:p>
        </p:txBody>
      </p:sp>
      <p:pic>
        <p:nvPicPr>
          <p:cNvPr id="7170" name="Picture 2" descr="No Credit for Protein - Guiding Stars">
            <a:extLst>
              <a:ext uri="{FF2B5EF4-FFF2-40B4-BE49-F238E27FC236}">
                <a16:creationId xmlns:a16="http://schemas.microsoft.com/office/drawing/2014/main" id="{8936F5D2-7E8A-43C7-A2AF-D3D20939A41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14" t="36740" r="9017" b="3650"/>
          <a:stretch/>
        </p:blipFill>
        <p:spPr bwMode="auto">
          <a:xfrm>
            <a:off x="1666603" y="5740369"/>
            <a:ext cx="9906000" cy="45085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9D8055EE-42CF-4DCF-B22C-04560258655F}"/>
              </a:ext>
            </a:extLst>
          </p:cNvPr>
          <p:cNvSpPr txBox="1"/>
          <p:nvPr/>
        </p:nvSpPr>
        <p:spPr>
          <a:xfrm>
            <a:off x="13455743" y="6482315"/>
            <a:ext cx="4264094" cy="36009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Aim for SUCCESS!</a:t>
            </a:r>
          </a:p>
          <a:p>
            <a:r>
              <a:rPr lang="en-US" sz="3200" b="1" i="1" u="sng" dirty="0">
                <a:solidFill>
                  <a:srgbClr val="FF0000"/>
                </a:solidFill>
              </a:rPr>
              <a:t>Veggies have protein!</a:t>
            </a:r>
          </a:p>
          <a:p>
            <a:r>
              <a:rPr lang="en-US" sz="2800" dirty="0"/>
              <a:t>From peanut butter to baked beans plants are an excellent source of protein. And you can count them as your veggies too! Aim to eat plant proteins often.</a:t>
            </a:r>
            <a:endParaRPr lang="en-US" sz="2400" dirty="0"/>
          </a:p>
        </p:txBody>
      </p:sp>
      <p:pic>
        <p:nvPicPr>
          <p:cNvPr id="24" name="Graphic 23" descr="Bullseye outline">
            <a:extLst>
              <a:ext uri="{FF2B5EF4-FFF2-40B4-BE49-F238E27FC236}">
                <a16:creationId xmlns:a16="http://schemas.microsoft.com/office/drawing/2014/main" id="{1849667E-4381-45CD-892D-58350F9B07A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1690240" y="6493089"/>
            <a:ext cx="1723794" cy="17237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45429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88</TotalTime>
  <Words>1697</Words>
  <Application>Microsoft Office PowerPoint</Application>
  <PresentationFormat>Custom</PresentationFormat>
  <Paragraphs>296</Paragraphs>
  <Slides>19</Slides>
  <Notes>18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9" baseType="lpstr">
      <vt:lpstr>Assistant ExtraBold</vt:lpstr>
      <vt:lpstr>Courier New</vt:lpstr>
      <vt:lpstr>Assistant SemiBold</vt:lpstr>
      <vt:lpstr>Assistant Bold</vt:lpstr>
      <vt:lpstr>Assistant Regular</vt:lpstr>
      <vt:lpstr>Calibri</vt:lpstr>
      <vt:lpstr>Wingdings</vt:lpstr>
      <vt:lpstr>Arial</vt:lpstr>
      <vt:lpstr>Assistan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nimalist Social Media Strategy Presentation with Soft Colors</dc:title>
  <dc:creator>14129</dc:creator>
  <cp:lastModifiedBy>SUZANNAH GERBER</cp:lastModifiedBy>
  <cp:revision>194</cp:revision>
  <dcterms:created xsi:type="dcterms:W3CDTF">2006-08-16T00:00:00Z</dcterms:created>
  <dcterms:modified xsi:type="dcterms:W3CDTF">2023-11-03T20:45:56Z</dcterms:modified>
  <dc:identifier>DAE7nbwep5o</dc:identifier>
</cp:coreProperties>
</file>